
<file path=[Content_Types].xml><?xml version="1.0" encoding="utf-8"?>
<Types xmlns="http://schemas.openxmlformats.org/package/2006/content-types">
  <Default Extension="tmp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7" r:id="rId2"/>
  </p:sldIdLst>
  <p:sldSz cx="6858000" cy="9906000" type="A4"/>
  <p:notesSz cx="6797675" cy="98742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020FE"/>
    <a:srgbClr val="FDB67A"/>
    <a:srgbClr val="FD9950"/>
    <a:srgbClr val="F797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40" autoAdjust="0"/>
    <p:restoredTop sz="94660"/>
  </p:normalViewPr>
  <p:slideViewPr>
    <p:cSldViewPr snapToGrid="0">
      <p:cViewPr>
        <p:scale>
          <a:sx n="150" d="100"/>
          <a:sy n="150" d="100"/>
        </p:scale>
        <p:origin x="288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953184-A5AB-41E1-AADF-A482A5B901D6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6313" y="1233488"/>
            <a:ext cx="2305050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690749-9845-429A-94A2-81F5EE9EA55F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969524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726843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483271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46242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47944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55704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88075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4179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06291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017549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394864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800258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31546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16CB61A1-32FB-4877-BFC9-0711A2D3B0DF}"/>
              </a:ext>
            </a:extLst>
          </p:cNvPr>
          <p:cNvSpPr txBox="1"/>
          <p:nvPr/>
        </p:nvSpPr>
        <p:spPr>
          <a:xfrm>
            <a:off x="84221" y="132346"/>
            <a:ext cx="2875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3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B5CE6B11-DAD5-41BA-A8A0-0BC2BCEAA162}"/>
              </a:ext>
            </a:extLst>
          </p:cNvPr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2" t="3372" r="10448" b="45101"/>
          <a:stretch/>
        </p:blipFill>
        <p:spPr>
          <a:xfrm rot="5400000">
            <a:off x="-2320592" y="3060393"/>
            <a:ext cx="7924800" cy="280736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F7656538-220C-43B4-BC5F-4BCCABE7D5DA}"/>
              </a:ext>
            </a:extLst>
          </p:cNvPr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553" t="13041" r="-403" b="69098"/>
          <a:stretch/>
        </p:blipFill>
        <p:spPr>
          <a:xfrm>
            <a:off x="3045493" y="1479522"/>
            <a:ext cx="986590" cy="973140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40A533A3-0E50-4A56-B722-529BEC244FA5}"/>
              </a:ext>
            </a:extLst>
          </p:cNvPr>
          <p:cNvSpPr/>
          <p:nvPr/>
        </p:nvSpPr>
        <p:spPr>
          <a:xfrm>
            <a:off x="-1" y="8426478"/>
            <a:ext cx="6772275" cy="7790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Supplementary Figure 3 – Protein expression changes measured by NPX</a:t>
            </a:r>
            <a:endParaRPr lang="en-GB" sz="12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Normalized protein expression (NPX) levels of chemokines measured by O-link PEA assay normalized to Isotype Control.</a:t>
            </a:r>
            <a:endParaRPr lang="en-GB" sz="12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77169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420</TotalTime>
  <Words>32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ylor, Molly</dc:creator>
  <cp:lastModifiedBy>Azarse, Elma Kadile</cp:lastModifiedBy>
  <cp:revision>302</cp:revision>
  <cp:lastPrinted>2019-02-05T09:56:44Z</cp:lastPrinted>
  <dcterms:created xsi:type="dcterms:W3CDTF">2018-07-09T15:32:49Z</dcterms:created>
  <dcterms:modified xsi:type="dcterms:W3CDTF">2019-11-21T12:50:50Z</dcterms:modified>
</cp:coreProperties>
</file>